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0" d="100"/>
          <a:sy n="400" d="100"/>
        </p:scale>
        <p:origin x="-21450" y="-6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9512E8-3B13-4A65-98BC-81714ACBA7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FBE7444-70DD-42A5-8BAC-C4CEF8A958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33513B-5C25-4FDB-9752-E02B79DC2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907CBB-B85D-4AAF-8694-BFF6F120B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11F938-60F2-448C-9BF1-8E9709DB0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837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829D6F-C92F-48F3-98C6-1A1BEA992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16E2EB-2D8F-4214-83CE-58029A3CA1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0DD4E9-1F38-4ECC-9B3D-516DEC8AA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84B9C0-B58D-40D4-98F5-278579A4D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3E1D45-9294-4498-8189-709E46652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9642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695C58D-E115-4DE0-B926-919937502F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5095DB8-A189-4593-A8BB-EEA8A7EBC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EDCFEC-2119-4D09-838D-16FC00DB6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F92EF3-C949-4C7D-931A-9321D85D5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04F9C9-BA11-453A-8782-3AC12B49A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0401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7E2C2D-6BA4-49F5-9AC7-6E2F678D50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1C80BA-A231-481F-AC39-5C79B537EA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22FAA5-4854-4E54-A25E-843B1548F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C51517-CF52-4DE4-96B6-F20403964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F70A7C-EE60-4D60-8C9B-6824C563B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0144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C95ECD-34A5-4B9C-989F-201A10C67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31A08F0-1094-43B2-8146-7BE948DD41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9804A9-1EFF-476A-9641-B004116EF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873C81-0FF3-46E2-BE98-C1B40AB13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37E26D-CE24-4E1C-BBCA-D2FE90EDF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9883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710E3F-1F59-43B3-A942-B0672104B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308EAA1-3531-4D8D-A846-721D6F8534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03E99F-2B98-4714-9F10-FAC484B262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BD8F3C8-A843-4CF0-BD71-3500EF5CF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B8E07B-480B-4275-AD9F-854F6164C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3DAF54-C51C-4DEF-B6C4-318D79298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7492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B5A06D-4FA0-4563-8B2A-3F471F73F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FCEBC3-07B9-4189-AC64-C766DD3488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BB7932-A9F4-4529-A0C9-41A4B7E50A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435A907-F56E-49AE-8CA0-A19FB76BB0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E843702-9C6A-4446-A472-80F9F5552F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B3B2475-B084-4F8D-8287-9C84EB8F4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597BEA6-F502-47B6-AC33-9B2A41DB1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891D42F-2421-4DC8-BE8E-6526B2642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0058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5086D8-ED3F-4B2B-B068-0C6C9D5174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9B4B741-DA2C-4A2E-9BA8-CC4EA9A3B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029EC7B-CA1D-47A1-B207-D4C2B3F64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C81B31A-9241-45E9-B836-0008DB38E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566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85FD1AB-65AE-4837-8176-0DEA23E41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14203AA-9BC5-4FDB-B62D-6BAB89F09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C745FCF-DAAE-4393-92E3-6DA839C71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2920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B1F38-6797-4865-9BCD-612813E07A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9BF2A2-C846-4548-954C-6E84249159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A21FAE0-7B39-46C3-AA00-7DA05D2652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62CEF7-B156-49EC-964B-EC4F6FAAA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28D474-620F-4E5F-926F-483724955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6C4B28-FABC-4E48-B5D2-6EB6EC084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449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349930-CC12-4561-BE7C-16458FE1F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331CA5C-3F34-4EB7-AB66-1D35467412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605081D-C8A3-4476-B2B0-6DECFE7C1E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1204A9-6029-4204-97FA-AC8CDE65A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FB0150-4DB8-482A-B39C-AB36D16D8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AF8135-E40A-4CA9-87EB-630D4A659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047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0217366-8D7B-4163-99FC-0BF751B6D7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3689545-1F60-4723-B754-8A1137D6B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2E785D-6BD4-44FF-8A61-C3AB9F0CDC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9E479-2A8D-4521-A68F-66FF763162B1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E68FF8-4E08-4A2C-B3F2-D3EB816208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E2DCEF-1C77-4F1F-8CEA-1A6355A97C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62E79-DAE4-40AE-B285-5291E5FC8A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480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337D21A-21C3-4954-B4DC-93A6136436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0953" y="349624"/>
            <a:ext cx="7244334" cy="50292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6AA3368-DB93-449B-9B7B-EF4D3A57DF67}"/>
              </a:ext>
            </a:extLst>
          </p:cNvPr>
          <p:cNvSpPr txBox="1"/>
          <p:nvPr/>
        </p:nvSpPr>
        <p:spPr>
          <a:xfrm>
            <a:off x="2397609" y="5639261"/>
            <a:ext cx="689699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Figure S1. </a:t>
            </a:r>
            <a:r>
              <a:rPr lang="en-US" altLang="zh-CN" sz="1600" dirty="0">
                <a:latin typeface="Palatino Linotype" panose="02040502050505030304" pitchFamily="18" charset="0"/>
                <a:cs typeface="Calibri" panose="020F0502020204030204" pitchFamily="34" charset="0"/>
              </a:rPr>
              <a:t>Uptake rates of NO</a:t>
            </a:r>
            <a:r>
              <a:rPr lang="en-US" altLang="zh-CN" sz="1600" baseline="-25000" dirty="0">
                <a:latin typeface="Palatino Linotype" panose="02040502050505030304" pitchFamily="18" charset="0"/>
                <a:cs typeface="Calibri" panose="020F0502020204030204" pitchFamily="34" charset="0"/>
              </a:rPr>
              <a:t>3</a:t>
            </a:r>
            <a:r>
              <a:rPr lang="en-US" altLang="zh-CN" sz="1600" baseline="30000" dirty="0">
                <a:latin typeface="Palatino Linotype" panose="02040502050505030304" pitchFamily="18" charset="0"/>
                <a:cs typeface="Calibri" panose="020F0502020204030204" pitchFamily="34" charset="0"/>
              </a:rPr>
              <a:t>-</a:t>
            </a:r>
            <a:r>
              <a:rPr lang="en-US" altLang="zh-CN" sz="1600" dirty="0">
                <a:latin typeface="Palatino Linotype" panose="02040502050505030304" pitchFamily="18" charset="0"/>
                <a:cs typeface="Calibri" panose="020F0502020204030204" pitchFamily="34" charset="0"/>
              </a:rPr>
              <a:t> in four maize inbred lines. The dots represent the NO</a:t>
            </a:r>
            <a:r>
              <a:rPr lang="en-US" altLang="zh-CN" sz="1600" baseline="-25000" dirty="0">
                <a:latin typeface="Palatino Linotype" panose="02040502050505030304" pitchFamily="18" charset="0"/>
                <a:cs typeface="Calibri" panose="020F0502020204030204" pitchFamily="34" charset="0"/>
              </a:rPr>
              <a:t>3</a:t>
            </a:r>
            <a:r>
              <a:rPr lang="en-US" altLang="zh-CN" sz="1600" baseline="30000" dirty="0">
                <a:latin typeface="Palatino Linotype" panose="02040502050505030304" pitchFamily="18" charset="0"/>
                <a:cs typeface="Calibri" panose="020F0502020204030204" pitchFamily="34" charset="0"/>
              </a:rPr>
              <a:t>-</a:t>
            </a:r>
            <a:r>
              <a:rPr lang="en-US" altLang="zh-CN" sz="1600" dirty="0">
                <a:latin typeface="Palatino Linotype" panose="02040502050505030304" pitchFamily="18" charset="0"/>
                <a:cs typeface="Calibri" panose="020F0502020204030204" pitchFamily="34" charset="0"/>
              </a:rPr>
              <a:t> uptake rate at a specific time point.</a:t>
            </a:r>
          </a:p>
        </p:txBody>
      </p:sp>
    </p:spTree>
    <p:extLst>
      <p:ext uri="{BB962C8B-B14F-4D97-AF65-F5344CB8AC3E}">
        <p14:creationId xmlns:p14="http://schemas.microsoft.com/office/powerpoint/2010/main" val="974996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3E4CA7C-7983-4397-955F-E5714E347B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95233"/>
            <a:ext cx="12192000" cy="306753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E945F1B-969B-4914-9C23-AC7F79BF3D5D}"/>
              </a:ext>
            </a:extLst>
          </p:cNvPr>
          <p:cNvSpPr txBox="1"/>
          <p:nvPr/>
        </p:nvSpPr>
        <p:spPr>
          <a:xfrm>
            <a:off x="1295212" y="5084762"/>
            <a:ext cx="925292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Figure S2. </a:t>
            </a:r>
            <a:r>
              <a:rPr lang="en-US" altLang="zh-CN" sz="1600" dirty="0">
                <a:latin typeface="Palatino Linotype" panose="02040502050505030304" pitchFamily="18" charset="0"/>
                <a:cs typeface="Calibri" panose="020F0502020204030204" pitchFamily="34" charset="0"/>
              </a:rPr>
              <a:t>Heat map of </a:t>
            </a:r>
            <a:r>
              <a:rPr lang="en-US" altLang="zh-CN" sz="16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NRT</a:t>
            </a:r>
            <a:r>
              <a:rPr lang="en-US" altLang="zh-CN" sz="1600" dirty="0">
                <a:latin typeface="Palatino Linotype" panose="02040502050505030304" pitchFamily="18" charset="0"/>
                <a:cs typeface="Calibri" panose="020F0502020204030204" pitchFamily="34" charset="0"/>
              </a:rPr>
              <a:t> genes expression profile in response to different abiotic stresses.</a:t>
            </a:r>
          </a:p>
        </p:txBody>
      </p:sp>
    </p:spTree>
    <p:extLst>
      <p:ext uri="{BB962C8B-B14F-4D97-AF65-F5344CB8AC3E}">
        <p14:creationId xmlns:p14="http://schemas.microsoft.com/office/powerpoint/2010/main" val="3396051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43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Palatino Linotype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文</dc:creator>
  <cp:lastModifiedBy>MDPI</cp:lastModifiedBy>
  <cp:revision>10</cp:revision>
  <dcterms:created xsi:type="dcterms:W3CDTF">2023-07-19T02:16:53Z</dcterms:created>
  <dcterms:modified xsi:type="dcterms:W3CDTF">2023-08-18T09:20:16Z</dcterms:modified>
</cp:coreProperties>
</file>